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42"/>
    <p:restoredTop sz="94628"/>
  </p:normalViewPr>
  <p:slideViewPr>
    <p:cSldViewPr snapToGrid="0">
      <p:cViewPr varScale="1">
        <p:scale>
          <a:sx n="86" d="100"/>
          <a:sy n="86" d="100"/>
        </p:scale>
        <p:origin x="272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rijal/Documents/UCANR%207.30.25/IPM%20Advisor%20content/My%20publications/Preparation/PEER%20REVIEWED/2025/FB%20monitoring/FHB_Monitoring_2022-23_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rijal/Documents/UCANR%207.30.25/IPM%20Advisor%20content/My%20publications/Preparation/PEER%20REVIEWED/2025/FB%20monitoring/FHB_Monitoring_2022-23_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rijal/Documents/UCANR%207.30.25/IPM%20Advisor%20content/My%20publications/Preparation/PEER%20REVIEWED/2025/FB%20monitoring/FHB_Monitoring_2022-23_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094557849430336"/>
          <c:y val="0.1655801431563797"/>
          <c:w val="0.72612922867362728"/>
          <c:h val="0.51041253611284199"/>
        </c:manualLayout>
      </c:layout>
      <c:lineChart>
        <c:grouping val="stacked"/>
        <c:varyColors val="0"/>
        <c:ser>
          <c:idx val="0"/>
          <c:order val="0"/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s 2023'!$E$70:$Y$70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25</c:v>
                  </c:pt>
                  <c:pt idx="6">
                    <c:v>0.25</c:v>
                  </c:pt>
                  <c:pt idx="7">
                    <c:v>0.28867513459481287</c:v>
                  </c:pt>
                  <c:pt idx="8">
                    <c:v>0.28867513459481287</c:v>
                  </c:pt>
                  <c:pt idx="9">
                    <c:v>0.5</c:v>
                  </c:pt>
                  <c:pt idx="10">
                    <c:v>0</c:v>
                  </c:pt>
                  <c:pt idx="11">
                    <c:v>0.47871355387816905</c:v>
                  </c:pt>
                  <c:pt idx="12">
                    <c:v>0.47871355387816905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.25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</c:numCache>
              </c:numRef>
            </c:plus>
            <c:minus>
              <c:numRef>
                <c:f>'graphs 2023'!$E$70:$Y$70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25</c:v>
                  </c:pt>
                  <c:pt idx="6">
                    <c:v>0.25</c:v>
                  </c:pt>
                  <c:pt idx="7">
                    <c:v>0.28867513459481287</c:v>
                  </c:pt>
                  <c:pt idx="8">
                    <c:v>0.28867513459481287</c:v>
                  </c:pt>
                  <c:pt idx="9">
                    <c:v>0.5</c:v>
                  </c:pt>
                  <c:pt idx="10">
                    <c:v>0</c:v>
                  </c:pt>
                  <c:pt idx="11">
                    <c:v>0.47871355387816905</c:v>
                  </c:pt>
                  <c:pt idx="12">
                    <c:v>0.47871355387816905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.25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s 2023'!$C$33:$C$53</c:f>
              <c:numCache>
                <c:formatCode>m/d/yy</c:formatCode>
                <c:ptCount val="21"/>
                <c:pt idx="0">
                  <c:v>45049</c:v>
                </c:pt>
                <c:pt idx="1">
                  <c:v>45055</c:v>
                </c:pt>
                <c:pt idx="2">
                  <c:v>45065</c:v>
                </c:pt>
                <c:pt idx="3">
                  <c:v>45069</c:v>
                </c:pt>
                <c:pt idx="4">
                  <c:v>45076</c:v>
                </c:pt>
                <c:pt idx="5">
                  <c:v>45085</c:v>
                </c:pt>
                <c:pt idx="6">
                  <c:v>45090</c:v>
                </c:pt>
                <c:pt idx="7">
                  <c:v>45097</c:v>
                </c:pt>
                <c:pt idx="8">
                  <c:v>45104</c:v>
                </c:pt>
                <c:pt idx="9">
                  <c:v>45110</c:v>
                </c:pt>
                <c:pt idx="10">
                  <c:v>45118</c:v>
                </c:pt>
                <c:pt idx="11">
                  <c:v>45125</c:v>
                </c:pt>
                <c:pt idx="12">
                  <c:v>45131</c:v>
                </c:pt>
                <c:pt idx="13">
                  <c:v>45139</c:v>
                </c:pt>
                <c:pt idx="14">
                  <c:v>45146</c:v>
                </c:pt>
                <c:pt idx="15">
                  <c:v>45153</c:v>
                </c:pt>
                <c:pt idx="16">
                  <c:v>45160</c:v>
                </c:pt>
                <c:pt idx="17">
                  <c:v>45166</c:v>
                </c:pt>
                <c:pt idx="18">
                  <c:v>45181</c:v>
                </c:pt>
                <c:pt idx="19">
                  <c:v>45188</c:v>
                </c:pt>
                <c:pt idx="20">
                  <c:v>45202</c:v>
                </c:pt>
              </c:numCache>
            </c:numRef>
          </c:cat>
          <c:val>
            <c:numRef>
              <c:f>'graphs 2023'!$E$68:$Y$68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5</c:v>
                </c:pt>
                <c:pt idx="6">
                  <c:v>0.25</c:v>
                </c:pt>
                <c:pt idx="7">
                  <c:v>0.5</c:v>
                </c:pt>
                <c:pt idx="8">
                  <c:v>0.5</c:v>
                </c:pt>
                <c:pt idx="9">
                  <c:v>0.5</c:v>
                </c:pt>
                <c:pt idx="10">
                  <c:v>0</c:v>
                </c:pt>
                <c:pt idx="11">
                  <c:v>2.75</c:v>
                </c:pt>
                <c:pt idx="12">
                  <c:v>0.75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25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09-2B40-A2C3-4EFAC1CA15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81127792"/>
        <c:axId val="444709304"/>
      </c:lineChart>
      <c:catAx>
        <c:axId val="581127792"/>
        <c:scaling>
          <c:orientation val="minMax"/>
        </c:scaling>
        <c:delete val="0"/>
        <c:axPos val="b"/>
        <c:numFmt formatCode="[$-409]d\-mmm;@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44709304"/>
        <c:crosses val="autoZero"/>
        <c:auto val="0"/>
        <c:lblAlgn val="ctr"/>
        <c:lblOffset val="100"/>
        <c:noMultiLvlLbl val="0"/>
      </c:catAx>
      <c:valAx>
        <c:axId val="444709304"/>
        <c:scaling>
          <c:orientation val="minMax"/>
          <c:max val="3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u="none" strike="noStrike" kern="12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(</a:t>
                </a:r>
                <a:r>
                  <a:rPr lang="en-US" sz="1200" b="0" i="0" u="none" strike="noStrike" kern="120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±SE) </a:t>
                </a:r>
                <a:r>
                  <a:rPr lang="en-US" sz="1200" b="0" i="1" u="none" strike="noStrike" kern="120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. </a:t>
                </a:r>
                <a:r>
                  <a:rPr lang="en-US" sz="1200" b="0" i="1" u="none" strike="noStrike" kern="1200" baseline="0" dirty="0" err="1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i</a:t>
                </a:r>
                <a:r>
                  <a:rPr lang="en-US" sz="1200" b="0" i="1" u="none" strike="noStrike" kern="120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b="0" i="0" u="none" strike="noStrike" kern="120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ults/trap/week</a:t>
                </a:r>
                <a:endParaRPr lang="en-US" sz="1200" b="0" i="0" u="none" strike="noStrike" kern="1200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2822258770207015E-2"/>
              <c:y val="0.204419574576559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bg2">
                <a:lumMod val="1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81127792"/>
        <c:crosses val="autoZero"/>
        <c:crossBetween val="between"/>
      </c:valAx>
      <c:spPr>
        <a:solidFill>
          <a:schemeClr val="bg1"/>
        </a:solidFill>
        <a:ln>
          <a:solidFill>
            <a:schemeClr val="tx1"/>
          </a:solidFill>
        </a:ln>
        <a:effectLst/>
      </c:spPr>
    </c:plotArea>
    <c:plotVisOnly val="1"/>
    <c:dispBlanksAs val="zero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95455900363328"/>
          <c:y val="0.1411623339141948"/>
          <c:w val="0.79342606885378264"/>
          <c:h val="0.60563728504375991"/>
        </c:manualLayout>
      </c:layout>
      <c:lineChart>
        <c:grouping val="stacked"/>
        <c:varyColors val="0"/>
        <c:ser>
          <c:idx val="0"/>
          <c:order val="0"/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aphs 2023'!$F$99:$Z$99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25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25</c:v>
                  </c:pt>
                  <c:pt idx="10">
                    <c:v>0.2886751345948128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5</c:v>
                  </c:pt>
                  <c:pt idx="14">
                    <c:v>0.25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</c:numCache>
              </c:numRef>
            </c:plus>
            <c:minus>
              <c:numRef>
                <c:f>'graphs 2023'!$F$99:$Z$99</c:f>
                <c:numCache>
                  <c:formatCode>General</c:formatCode>
                  <c:ptCount val="21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.25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.25</c:v>
                  </c:pt>
                  <c:pt idx="10">
                    <c:v>0.2886751345948128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5</c:v>
                  </c:pt>
                  <c:pt idx="14">
                    <c:v>0.25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graphs 2023'!$F$91:$Z$91</c:f>
              <c:numCache>
                <c:formatCode>m/d/yy</c:formatCode>
                <c:ptCount val="21"/>
                <c:pt idx="0">
                  <c:v>45049</c:v>
                </c:pt>
                <c:pt idx="1">
                  <c:v>45055</c:v>
                </c:pt>
                <c:pt idx="2">
                  <c:v>45065</c:v>
                </c:pt>
                <c:pt idx="3">
                  <c:v>45069</c:v>
                </c:pt>
                <c:pt idx="4">
                  <c:v>45076</c:v>
                </c:pt>
                <c:pt idx="5">
                  <c:v>45085</c:v>
                </c:pt>
                <c:pt idx="6">
                  <c:v>45090</c:v>
                </c:pt>
                <c:pt idx="7">
                  <c:v>45097</c:v>
                </c:pt>
                <c:pt idx="8">
                  <c:v>45104</c:v>
                </c:pt>
                <c:pt idx="9">
                  <c:v>45110</c:v>
                </c:pt>
                <c:pt idx="10">
                  <c:v>45118</c:v>
                </c:pt>
                <c:pt idx="11">
                  <c:v>45125</c:v>
                </c:pt>
                <c:pt idx="12">
                  <c:v>45131</c:v>
                </c:pt>
                <c:pt idx="13">
                  <c:v>45139</c:v>
                </c:pt>
                <c:pt idx="14">
                  <c:v>45146</c:v>
                </c:pt>
                <c:pt idx="15">
                  <c:v>45153</c:v>
                </c:pt>
                <c:pt idx="16">
                  <c:v>45160</c:v>
                </c:pt>
                <c:pt idx="17">
                  <c:v>45166</c:v>
                </c:pt>
                <c:pt idx="18">
                  <c:v>45181</c:v>
                </c:pt>
                <c:pt idx="19">
                  <c:v>45188</c:v>
                </c:pt>
                <c:pt idx="20">
                  <c:v>45202</c:v>
                </c:pt>
              </c:numCache>
            </c:numRef>
          </c:cat>
          <c:val>
            <c:numRef>
              <c:f>'graphs 2023'!$F$96:$Z$96</c:f>
              <c:numCache>
                <c:formatCode>General</c:formatCode>
                <c:ptCount val="2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2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.25</c:v>
                </c:pt>
                <c:pt idx="10">
                  <c:v>0.5</c:v>
                </c:pt>
                <c:pt idx="11">
                  <c:v>0</c:v>
                </c:pt>
                <c:pt idx="12">
                  <c:v>0</c:v>
                </c:pt>
                <c:pt idx="13">
                  <c:v>0.25</c:v>
                </c:pt>
                <c:pt idx="14">
                  <c:v>0.25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EA0-9742-BDBA-64D6A250A3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81127792"/>
        <c:axId val="444709304"/>
      </c:lineChart>
      <c:catAx>
        <c:axId val="581127792"/>
        <c:scaling>
          <c:orientation val="minMax"/>
        </c:scaling>
        <c:delete val="0"/>
        <c:axPos val="b"/>
        <c:numFmt formatCode="[$-409]d\-mmm;@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44709304"/>
        <c:crosses val="autoZero"/>
        <c:auto val="0"/>
        <c:lblAlgn val="ctr"/>
        <c:lblOffset val="100"/>
        <c:noMultiLvlLbl val="0"/>
      </c:catAx>
      <c:valAx>
        <c:axId val="44470930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Mean (±SE) </a:t>
                </a:r>
                <a:r>
                  <a:rPr lang="en-US" i="1" dirty="0"/>
                  <a:t>C. </a:t>
                </a:r>
                <a:r>
                  <a:rPr lang="en-US" i="1" dirty="0" err="1"/>
                  <a:t>mali</a:t>
                </a:r>
                <a:r>
                  <a:rPr lang="en-US" i="1" dirty="0"/>
                  <a:t> </a:t>
                </a:r>
                <a:r>
                  <a:rPr lang="en-US" dirty="0"/>
                  <a:t>adults/trap/week</a:t>
                </a:r>
              </a:p>
            </c:rich>
          </c:tx>
          <c:layout>
            <c:manualLayout>
              <c:xMode val="edge"/>
              <c:yMode val="edge"/>
              <c:x val="1.3541286545992083E-2"/>
              <c:y val="0.212977054254032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bg2">
                <a:lumMod val="1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81127792"/>
        <c:crosses val="autoZero"/>
        <c:crossBetween val="between"/>
        <c:majorUnit val="0.25"/>
      </c:valAx>
      <c:spPr>
        <a:solidFill>
          <a:schemeClr val="bg1"/>
        </a:solidFill>
        <a:ln>
          <a:solidFill>
            <a:sysClr val="windowText" lastClr="000000">
              <a:lumMod val="95000"/>
              <a:lumOff val="5000"/>
            </a:sysClr>
          </a:solidFill>
        </a:ln>
        <a:effectLst/>
      </c:spPr>
    </c:plotArea>
    <c:plotVisOnly val="1"/>
    <c:dispBlanksAs val="zero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19842110334101"/>
          <c:y val="0.1070703243037212"/>
          <c:w val="0.77961076242656502"/>
          <c:h val="0.63023154789611024"/>
        </c:manualLayout>
      </c:layout>
      <c:lineChart>
        <c:grouping val="stacked"/>
        <c:varyColors val="0"/>
        <c:ser>
          <c:idx val="0"/>
          <c:order val="0"/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2022 data for analysis'!$C$41:$U$41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25</c:v>
                  </c:pt>
                  <c:pt idx="4">
                    <c:v>0</c:v>
                  </c:pt>
                  <c:pt idx="5">
                    <c:v>0.25</c:v>
                  </c:pt>
                  <c:pt idx="6">
                    <c:v>0.25</c:v>
                  </c:pt>
                  <c:pt idx="7">
                    <c:v>0.75</c:v>
                  </c:pt>
                  <c:pt idx="8">
                    <c:v>1.181453906563152</c:v>
                  </c:pt>
                  <c:pt idx="9">
                    <c:v>0.28867513459481287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</c:numCache>
              </c:numRef>
            </c:plus>
            <c:minus>
              <c:numRef>
                <c:f>'2022 data for analysis'!$C$41:$U$41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25</c:v>
                  </c:pt>
                  <c:pt idx="4">
                    <c:v>0</c:v>
                  </c:pt>
                  <c:pt idx="5">
                    <c:v>0.25</c:v>
                  </c:pt>
                  <c:pt idx="6">
                    <c:v>0.25</c:v>
                  </c:pt>
                  <c:pt idx="7">
                    <c:v>0.75</c:v>
                  </c:pt>
                  <c:pt idx="8">
                    <c:v>1.181453906563152</c:v>
                  </c:pt>
                  <c:pt idx="9">
                    <c:v>0.28867513459481287</c:v>
                  </c:pt>
                  <c:pt idx="10">
                    <c:v>0</c:v>
                  </c:pt>
                  <c:pt idx="11">
                    <c:v>0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022 data for analysis'!$C$33:$U$33</c:f>
              <c:numCache>
                <c:formatCode>m/d/yy;@</c:formatCode>
                <c:ptCount val="19"/>
                <c:pt idx="0">
                  <c:v>44684</c:v>
                </c:pt>
                <c:pt idx="1">
                  <c:v>44691</c:v>
                </c:pt>
                <c:pt idx="2">
                  <c:v>44698</c:v>
                </c:pt>
                <c:pt idx="3">
                  <c:v>44705</c:v>
                </c:pt>
                <c:pt idx="4">
                  <c:v>44712</c:v>
                </c:pt>
                <c:pt idx="5">
                  <c:v>44719</c:v>
                </c:pt>
                <c:pt idx="6">
                  <c:v>44726</c:v>
                </c:pt>
                <c:pt idx="7">
                  <c:v>44733</c:v>
                </c:pt>
                <c:pt idx="8">
                  <c:v>44740</c:v>
                </c:pt>
                <c:pt idx="9">
                  <c:v>44747</c:v>
                </c:pt>
                <c:pt idx="10">
                  <c:v>44754</c:v>
                </c:pt>
                <c:pt idx="11">
                  <c:v>44761</c:v>
                </c:pt>
                <c:pt idx="12">
                  <c:v>44768</c:v>
                </c:pt>
                <c:pt idx="13">
                  <c:v>44775</c:v>
                </c:pt>
                <c:pt idx="14">
                  <c:v>44782</c:v>
                </c:pt>
                <c:pt idx="15">
                  <c:v>44789</c:v>
                </c:pt>
                <c:pt idx="16">
                  <c:v>44796</c:v>
                </c:pt>
                <c:pt idx="17">
                  <c:v>44803</c:v>
                </c:pt>
                <c:pt idx="18">
                  <c:v>44813</c:v>
                </c:pt>
              </c:numCache>
            </c:numRef>
          </c:cat>
          <c:val>
            <c:numRef>
              <c:f>'2022 data for analysis'!$C$38:$U$38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25</c:v>
                </c:pt>
                <c:pt idx="4">
                  <c:v>0</c:v>
                </c:pt>
                <c:pt idx="5">
                  <c:v>0.25</c:v>
                </c:pt>
                <c:pt idx="6">
                  <c:v>0.25</c:v>
                </c:pt>
                <c:pt idx="7">
                  <c:v>0.75</c:v>
                </c:pt>
                <c:pt idx="8">
                  <c:v>1.75</c:v>
                </c:pt>
                <c:pt idx="9">
                  <c:v>0.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FE8-0F4A-B062-263F0B6598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581127792"/>
        <c:axId val="444709304"/>
      </c:lineChart>
      <c:catAx>
        <c:axId val="581127792"/>
        <c:scaling>
          <c:orientation val="minMax"/>
        </c:scaling>
        <c:delete val="0"/>
        <c:axPos val="b"/>
        <c:numFmt formatCode="[$-409]d\-mmm;@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44709304"/>
        <c:crosses val="autoZero"/>
        <c:auto val="0"/>
        <c:lblAlgn val="ctr"/>
        <c:lblOffset val="100"/>
        <c:noMultiLvlLbl val="0"/>
      </c:catAx>
      <c:valAx>
        <c:axId val="444709304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Mean (±SE) </a:t>
                </a:r>
                <a:r>
                  <a:rPr lang="en-US" i="1" dirty="0"/>
                  <a:t>C. </a:t>
                </a:r>
                <a:r>
                  <a:rPr lang="en-US" i="1" dirty="0" err="1"/>
                  <a:t>mali</a:t>
                </a:r>
                <a:r>
                  <a:rPr lang="en-US" i="1" dirty="0"/>
                  <a:t> </a:t>
                </a:r>
                <a:r>
                  <a:rPr lang="en-US" dirty="0"/>
                  <a:t>adults/trap/week</a:t>
                </a:r>
              </a:p>
            </c:rich>
          </c:tx>
          <c:layout>
            <c:manualLayout>
              <c:xMode val="edge"/>
              <c:yMode val="edge"/>
              <c:x val="1.2799358862981553E-2"/>
              <c:y val="0.13694219045561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bg2">
                <a:lumMod val="1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81127792"/>
        <c:crosses val="autoZero"/>
        <c:crossBetween val="between"/>
      </c:valAx>
      <c:spPr>
        <a:solidFill>
          <a:schemeClr val="bg1"/>
        </a:solidFill>
        <a:ln>
          <a:solidFill>
            <a:sysClr val="windowText" lastClr="000000">
              <a:lumMod val="95000"/>
              <a:lumOff val="5000"/>
            </a:sysClr>
          </a:solidFill>
        </a:ln>
        <a:effectLst/>
      </c:spPr>
    </c:plotArea>
    <c:plotVisOnly val="1"/>
    <c:dispBlanksAs val="zero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89E99-DDC3-CF44-A085-68F4C44FF17E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E59272-80A3-454C-89B9-3603108B5F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5600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E59272-80A3-454C-89B9-3603108B5F5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35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290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005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897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997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333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892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427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653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48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866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144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52B23F-5C8F-664E-AEAB-990F45761CDF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84AFC3-18D3-4646-AB75-887F17DF8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447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D9A51E-D62D-2EA2-C1F6-81ECFB7293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C8A21EB-5968-1D8E-FADB-DCD315C38832}"/>
              </a:ext>
            </a:extLst>
          </p:cNvPr>
          <p:cNvGrpSpPr/>
          <p:nvPr/>
        </p:nvGrpSpPr>
        <p:grpSpPr>
          <a:xfrm>
            <a:off x="613458" y="4632665"/>
            <a:ext cx="5250553" cy="2824480"/>
            <a:chOff x="625033" y="4771565"/>
            <a:chExt cx="5149565" cy="2824480"/>
          </a:xfrm>
          <a:noFill/>
        </p:grpSpPr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CE224FE1-3DE8-9E3B-C9BB-D069D539FCA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891724316"/>
                </p:ext>
              </p:extLst>
            </p:nvPr>
          </p:nvGraphicFramePr>
          <p:xfrm>
            <a:off x="625033" y="4771565"/>
            <a:ext cx="5149565" cy="28244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7157EB1-016D-6E9D-E4B7-2235E88223EB}"/>
                </a:ext>
              </a:extLst>
            </p:cNvPr>
            <p:cNvSpPr txBox="1"/>
            <p:nvPr/>
          </p:nvSpPr>
          <p:spPr>
            <a:xfrm>
              <a:off x="1819153" y="5242909"/>
              <a:ext cx="322163" cy="27740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348B711-3823-800B-1004-D500E3B69789}"/>
              </a:ext>
            </a:extLst>
          </p:cNvPr>
          <p:cNvSpPr txBox="1"/>
          <p:nvPr/>
        </p:nvSpPr>
        <p:spPr>
          <a:xfrm>
            <a:off x="282730" y="7341403"/>
            <a:ext cx="638428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ekly averag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ults (± SE) captured in A) (Z)-3-hexenyl baited purple panel traps during the 2022 season, B) (Z)-3-hexenyl baited purple panel trap during the 2023 season, and C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bai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urple triangular traps during the 2023 season, in a Merced County, CA, walnut orchard. Panel traps (20 × 30 cm) were constructed from a single layer of corrugated plastic overlaid with transparent double-sided adhesive. These traps were mounted on two 1.2-m tall wooden stakes. Triangular traps (10 cm wide × 1.2 m tall) were formed by folding corrugated plastic with adhesive applied to the exterior; these were installed vertically on the ground using a wooden stake for support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7822C99-4700-F889-58AC-973F1CA852F4}"/>
              </a:ext>
            </a:extLst>
          </p:cNvPr>
          <p:cNvGrpSpPr/>
          <p:nvPr/>
        </p:nvGrpSpPr>
        <p:grpSpPr>
          <a:xfrm>
            <a:off x="902825" y="2580071"/>
            <a:ext cx="4847693" cy="2341872"/>
            <a:chOff x="902825" y="2580071"/>
            <a:chExt cx="4847693" cy="2341872"/>
          </a:xfrm>
        </p:grpSpPr>
        <p:graphicFrame>
          <p:nvGraphicFramePr>
            <p:cNvPr id="10" name="Chart 9">
              <a:extLst>
                <a:ext uri="{FF2B5EF4-FFF2-40B4-BE49-F238E27FC236}">
                  <a16:creationId xmlns:a16="http://schemas.microsoft.com/office/drawing/2014/main" id="{B33ABD6D-67D6-F448-BDAC-13984C980EE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2897931"/>
                </p:ext>
              </p:extLst>
            </p:nvPr>
          </p:nvGraphicFramePr>
          <p:xfrm>
            <a:off x="902825" y="2580071"/>
            <a:ext cx="4847693" cy="23418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2F09FA2-652F-C139-7D16-FCEF72EA3A53}"/>
                </a:ext>
              </a:extLst>
            </p:cNvPr>
            <p:cNvSpPr txBox="1"/>
            <p:nvPr/>
          </p:nvSpPr>
          <p:spPr>
            <a:xfrm>
              <a:off x="1832657" y="2918324"/>
              <a:ext cx="322163" cy="27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B9F86C96-C023-A762-029C-96B1CA714321}"/>
              </a:ext>
            </a:extLst>
          </p:cNvPr>
          <p:cNvGrpSpPr/>
          <p:nvPr/>
        </p:nvGrpSpPr>
        <p:grpSpPr>
          <a:xfrm>
            <a:off x="902825" y="419012"/>
            <a:ext cx="4961186" cy="2253659"/>
            <a:chOff x="902825" y="419012"/>
            <a:chExt cx="4961186" cy="2253659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4734300A-9FBC-F040-97AE-F74904FD9A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34051310"/>
                </p:ext>
              </p:extLst>
            </p:nvPr>
          </p:nvGraphicFramePr>
          <p:xfrm>
            <a:off x="902825" y="419012"/>
            <a:ext cx="4961186" cy="22536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F88728-85B8-8F8F-A39C-EEA7603B7EDF}"/>
                </a:ext>
              </a:extLst>
            </p:cNvPr>
            <p:cNvSpPr txBox="1"/>
            <p:nvPr/>
          </p:nvSpPr>
          <p:spPr>
            <a:xfrm>
              <a:off x="1811434" y="674765"/>
              <a:ext cx="322163" cy="277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6665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</TotalTime>
  <Words>180</Words>
  <Application>Microsoft Macintosh PowerPoint</Application>
  <PresentationFormat>Letter Paper (8.5x11 in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halendra P Rijal</dc:creator>
  <cp:lastModifiedBy>Jhalendra P Rijal</cp:lastModifiedBy>
  <cp:revision>9</cp:revision>
  <dcterms:created xsi:type="dcterms:W3CDTF">2026-02-18T18:41:02Z</dcterms:created>
  <dcterms:modified xsi:type="dcterms:W3CDTF">2026-02-20T01:06:22Z</dcterms:modified>
</cp:coreProperties>
</file>